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97" d="100"/>
          <a:sy n="97" d="100"/>
        </p:scale>
        <p:origin x="96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F54638-B0DE-46FC-A4C4-7A3403CEC2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1726EE6-E548-4E97-9F6F-426A4CD67B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EB7942-5503-4865-AFF4-63D683D0C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1E6944B-98EC-4E64-9B39-C5C1518888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C3CD6E7-D644-4B3F-AA60-F908C0EC9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1697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851376-AC6D-42E7-91C3-868EFCCB3E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5F3F02A-E408-46B8-84DE-0D62616C53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08ED5A8-7A8C-4185-9458-9991AE4446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5D7CB57-1821-4A5B-96A0-0BE9F67D9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B277D18-3D2E-46A0-8DE3-716398FD9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5943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B4A6A5FF-8EF2-4378-9059-0E9ACE4A53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44B112B-81CD-4C67-8C64-56BE5DE90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77ACF6-7DCE-4A7F-A69D-32AEC8F38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1DCFE17-5D0E-46A0-AB92-FA7A940EE9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A99A74F-302B-472B-8DCA-0CE09DEEE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765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2913BD7-9F3D-4180-A641-EC99B48940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2A097BA-3799-46BD-95E6-7AD2849933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739B341-E57F-4930-BC4D-795EA2061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1A3C910-2319-4046-ACE7-A9D6254B0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5E748E2-0DF9-4F7F-9243-0DEA3826E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746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E7AF777-C9AC-4997-AA6C-9C3CDEB09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D364F93-2EA2-4E78-A1FF-E4BFAD77B7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E24DCD5-7010-4BD3-939D-83AC60E29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BF4C4AB-B3D8-4606-AE46-10CE0846B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4B8AB8F-0731-4D41-A6CB-5ADBAF7FE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6470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59A6B2-EE2F-4249-95AA-DD78206CCB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E085B3C-A126-429B-BEB0-D7EF747E282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E95E5B6-E1D4-46C8-807E-EE5165035A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A27B35B-0452-4BCA-9A8F-EF70AFA18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6FA2867-B804-4DC6-9EFB-EACBEF7DB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766DCA5-A41D-475F-8AA3-CA53C2358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7559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2608F4B-3B4B-4224-9281-194A6AECE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743B62E-C417-45CA-8C1A-553915454C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54FAF4B-E630-4938-AE62-91E906E1C1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82237940-714E-4424-B4BB-D90E985F03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D97F3021-8F9B-4F3C-A7BF-0D4348E09B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C3917500-1275-4C41-BC77-CC554E3D4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6BB5974-4917-4A77-B485-2BC0B850AE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64B0BADA-BA75-411A-9F29-4797F8CFD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7829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3CDFE86-77FB-491A-B64E-D8293BC09E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4169DE58-B09C-4022-986E-A95B50C040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7117D388-F3CB-4243-9F86-6A7AF7D31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B024DAA-0E21-4998-B14F-FED430665F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4935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6A637DC5-532B-4F00-9DD6-851344C6F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865FF5F-AFE7-4D14-8F61-87A922417C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01A8FA2-A3DE-471D-B007-DB3FCAF87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2881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3D56441-940D-41A1-B5DD-E390CC1F63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EC35651-B2D7-4003-A675-78B0C849A9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6779868-F07A-4FDD-AC42-0DCF15914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7F9EEAE-9EEA-4131-BE5D-BB57CC772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2029FD8-964E-4D70-800E-07114247FB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5D99B1E-8FA0-4BAF-807A-BB223DB8E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6241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D78DBC-C5A0-46CC-8900-C270D1A42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DFC47DAE-A316-4683-BE3B-5462A9C9360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112AB42-26EA-4886-BFF4-C1E2A005C6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2440890-27CC-4A8B-8E8E-58FEB251B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2CD48AA-C815-4525-8532-3D14683FE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072E2D61-0702-4C65-BA8E-D192A7A1F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57565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787FADD8-8121-4B24-8918-54BB501C45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8D58F6F3-F6B6-43EA-B863-AF4D76DBEC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0B2633B-4AD7-4356-96E7-049E24F559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4F413-92D3-4E26-9D7E-AE7B5AD4086C}" type="datetimeFigureOut">
              <a:rPr lang="de-DE" smtClean="0"/>
              <a:t>14.03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AAC0011-A8C4-47AC-AD00-ABFE4FF064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831B647-A2D7-4AEA-9BC3-EB0C399141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FAAF8-A545-4AEB-BB3B-A9668A9CBDD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5956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A4707FE6-5121-4181-85F1-1C1319DC74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8018935"/>
              </p:ext>
            </p:extLst>
          </p:nvPr>
        </p:nvGraphicFramePr>
        <p:xfrm>
          <a:off x="226503" y="119820"/>
          <a:ext cx="6177480" cy="66270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81959">
                  <a:extLst>
                    <a:ext uri="{9D8B030D-6E8A-4147-A177-3AD203B41FA5}">
                      <a16:colId xmlns:a16="http://schemas.microsoft.com/office/drawing/2014/main" val="14571707"/>
                    </a:ext>
                  </a:extLst>
                </a:gridCol>
                <a:gridCol w="781959">
                  <a:extLst>
                    <a:ext uri="{9D8B030D-6E8A-4147-A177-3AD203B41FA5}">
                      <a16:colId xmlns:a16="http://schemas.microsoft.com/office/drawing/2014/main" val="785972450"/>
                    </a:ext>
                  </a:extLst>
                </a:gridCol>
                <a:gridCol w="781959">
                  <a:extLst>
                    <a:ext uri="{9D8B030D-6E8A-4147-A177-3AD203B41FA5}">
                      <a16:colId xmlns:a16="http://schemas.microsoft.com/office/drawing/2014/main" val="632251622"/>
                    </a:ext>
                  </a:extLst>
                </a:gridCol>
                <a:gridCol w="781959">
                  <a:extLst>
                    <a:ext uri="{9D8B030D-6E8A-4147-A177-3AD203B41FA5}">
                      <a16:colId xmlns:a16="http://schemas.microsoft.com/office/drawing/2014/main" val="2147620293"/>
                    </a:ext>
                  </a:extLst>
                </a:gridCol>
                <a:gridCol w="1407527">
                  <a:extLst>
                    <a:ext uri="{9D8B030D-6E8A-4147-A177-3AD203B41FA5}">
                      <a16:colId xmlns:a16="http://schemas.microsoft.com/office/drawing/2014/main" val="1823646695"/>
                    </a:ext>
                  </a:extLst>
                </a:gridCol>
                <a:gridCol w="1642117">
                  <a:extLst>
                    <a:ext uri="{9D8B030D-6E8A-4147-A177-3AD203B41FA5}">
                      <a16:colId xmlns:a16="http://schemas.microsoft.com/office/drawing/2014/main" val="69935260"/>
                    </a:ext>
                  </a:extLst>
                </a:gridCol>
              </a:tblGrid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 dirty="0">
                          <a:effectLst/>
                        </a:rPr>
                        <a:t> </a:t>
                      </a:r>
                      <a:r>
                        <a:rPr lang="de-DE" sz="1000" b="1" u="none" strike="noStrike" dirty="0" err="1">
                          <a:effectLst/>
                        </a:rPr>
                        <a:t>Laterality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>
                          <a:effectLst/>
                        </a:rPr>
                        <a:t>PTV cc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>
                          <a:effectLst/>
                        </a:rPr>
                        <a:t>CTVcc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>
                          <a:effectLst/>
                        </a:rPr>
                        <a:t>contralateral breast cc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1" u="none" strike="noStrike">
                          <a:effectLst/>
                        </a:rPr>
                        <a:t>contralateral breast Dmax</a:t>
                      </a:r>
                      <a:endParaRPr lang="de-DE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340255896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err="1">
                          <a:effectLst/>
                        </a:rPr>
                        <a:t>right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83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57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357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3,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829612321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2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err="1">
                          <a:effectLst/>
                        </a:rPr>
                        <a:t>left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9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8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44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633041022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3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539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282,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09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031036420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4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6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13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527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800890103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5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3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7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89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836866994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6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66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10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68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905679148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7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18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4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4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613370977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8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43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59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58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0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814577388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9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48,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47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094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4111127840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10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67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101,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594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3,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158402471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MRL#1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02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69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35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729482431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 </a:t>
                      </a:r>
                      <a:r>
                        <a:rPr lang="de-DE" sz="1000" u="none" strike="noStrike" dirty="0" err="1">
                          <a:effectLst/>
                        </a:rPr>
                        <a:t>mean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65,3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16,6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31,2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,8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064413088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 </a:t>
                      </a:r>
                      <a:r>
                        <a:rPr lang="de-DE" sz="1000" u="none" strike="noStrike" dirty="0" err="1">
                          <a:effectLst/>
                        </a:rPr>
                        <a:t>st</a:t>
                      </a:r>
                      <a:r>
                        <a:rPr lang="de-DE" sz="1000" u="none" strike="noStrike" dirty="0">
                          <a:effectLst/>
                        </a:rPr>
                        <a:t> </a:t>
                      </a:r>
                      <a:r>
                        <a:rPr lang="de-DE" sz="1000" u="none" strike="noStrike" dirty="0" err="1">
                          <a:effectLst/>
                        </a:rPr>
                        <a:t>dev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45,8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3,4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63,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,7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884025825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048881125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ght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261,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134,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444,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5</a:t>
                      </a: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491814992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2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353,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161,9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97,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072362859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3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61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3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1063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841693282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4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2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2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01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424766551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5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77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17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140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792815650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6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07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43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3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,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538993404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7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14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3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2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038981074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8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96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2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507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224288548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9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85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1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84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375367689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10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330,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64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504,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653820003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BI@CTL#1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65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60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92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139181648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 </a:t>
                      </a:r>
                      <a:r>
                        <a:rPr lang="de-DE" sz="1000" u="none" strike="noStrike" dirty="0" err="1">
                          <a:effectLst/>
                        </a:rPr>
                        <a:t>mean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99,0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0,5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26,87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,70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28564507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 </a:t>
                      </a:r>
                      <a:r>
                        <a:rPr lang="de-DE" sz="1000" u="none" strike="noStrike" dirty="0" err="1">
                          <a:effectLst/>
                        </a:rPr>
                        <a:t>st</a:t>
                      </a:r>
                      <a:r>
                        <a:rPr lang="de-DE" sz="1000" u="none" strike="noStrike" dirty="0">
                          <a:effectLst/>
                        </a:rPr>
                        <a:t> </a:t>
                      </a:r>
                      <a:r>
                        <a:rPr lang="de-DE" sz="1000" u="none" strike="noStrike" dirty="0" err="1">
                          <a:effectLst/>
                        </a:rPr>
                        <a:t>dev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9,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1,0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7,7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,51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64316905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 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705733833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07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28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73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5,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509993160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2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398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07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032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9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607242619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3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23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01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94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8,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606726953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4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979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64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69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7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826308694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5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287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90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637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19,8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521343303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6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670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24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12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4096511456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7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251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86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984,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3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128925023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8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979,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734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672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3,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741051712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9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216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359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151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10,5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129758665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10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igh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93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473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340,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2608048873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BI@CTL#11</a:t>
                      </a: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lef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682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211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225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3,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3426790602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 </a:t>
                      </a:r>
                      <a:r>
                        <a:rPr lang="de-DE" sz="1000" u="none" strike="noStrike" dirty="0" err="1">
                          <a:effectLst/>
                        </a:rPr>
                        <a:t>mean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1290,4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95,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831,3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9,06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517627784"/>
                  </a:ext>
                </a:extLst>
              </a:tr>
              <a:tr h="103603">
                <a:tc>
                  <a:txBody>
                    <a:bodyPr/>
                    <a:lstStyle/>
                    <a:p>
                      <a:pPr algn="l" fontAlgn="b"/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 </a:t>
                      </a:r>
                      <a:r>
                        <a:rPr lang="de-DE" sz="1000" u="none" strike="noStrike" dirty="0" err="1">
                          <a:effectLst/>
                        </a:rPr>
                        <a:t>st</a:t>
                      </a:r>
                      <a:r>
                        <a:rPr lang="de-DE" sz="1000" u="none" strike="noStrike" dirty="0">
                          <a:effectLst/>
                        </a:rPr>
                        <a:t> </a:t>
                      </a:r>
                      <a:r>
                        <a:rPr lang="de-DE" sz="1000" u="none" strike="noStrike" dirty="0" err="1">
                          <a:effectLst/>
                        </a:rPr>
                        <a:t>dev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623,1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527,9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556,57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5,92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80" marR="5180" marT="5180" marB="0" anchor="b"/>
                </a:tc>
                <a:extLst>
                  <a:ext uri="{0D108BD9-81ED-4DB2-BD59-A6C34878D82A}">
                    <a16:rowId xmlns:a16="http://schemas.microsoft.com/office/drawing/2014/main" val="955774916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C29696EF-2AF9-441F-A06A-6663D718082A}"/>
              </a:ext>
            </a:extLst>
          </p:cNvPr>
          <p:cNvSpPr txBox="1"/>
          <p:nvPr/>
        </p:nvSpPr>
        <p:spPr>
          <a:xfrm>
            <a:off x="8414158" y="4303552"/>
            <a:ext cx="3363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Table 2 </a:t>
            </a:r>
            <a:r>
              <a:rPr lang="de-DE" dirty="0" err="1"/>
              <a:t>supplementary</a:t>
            </a:r>
            <a:r>
              <a:rPr lang="de-DE" dirty="0"/>
              <a:t> material</a:t>
            </a:r>
          </a:p>
        </p:txBody>
      </p:sp>
    </p:spTree>
    <p:extLst>
      <p:ext uri="{BB962C8B-B14F-4D97-AF65-F5344CB8AC3E}">
        <p14:creationId xmlns:p14="http://schemas.microsoft.com/office/powerpoint/2010/main" val="594902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2</Words>
  <Application>Microsoft Office PowerPoint</Application>
  <PresentationFormat>Breitbild</PresentationFormat>
  <Paragraphs>24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Chiara De-Colle</dc:creator>
  <cp:lastModifiedBy>Sabine König</cp:lastModifiedBy>
  <cp:revision>21</cp:revision>
  <dcterms:created xsi:type="dcterms:W3CDTF">2021-07-13T16:18:21Z</dcterms:created>
  <dcterms:modified xsi:type="dcterms:W3CDTF">2022-03-14T10:03:39Z</dcterms:modified>
</cp:coreProperties>
</file>